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3160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1848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7066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2766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329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028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4010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1629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108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8953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8671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7563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B70EF-8AD5-4A85-BD29-B95EFB7CA971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7F748-3B34-4854-9C8E-B3B47F7F22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4535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20" t="20039" r="35012" b="19483"/>
          <a:stretch/>
        </p:blipFill>
        <p:spPr>
          <a:xfrm>
            <a:off x="565345" y="706413"/>
            <a:ext cx="2638022" cy="621561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905830" y="5621613"/>
            <a:ext cx="8201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a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 </a:t>
            </a:r>
          </a:p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25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358250" y="235717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931433" y="261709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7" t="6505" r="69647" b="11395"/>
          <a:stretch/>
        </p:blipFill>
        <p:spPr>
          <a:xfrm>
            <a:off x="4051241" y="706413"/>
            <a:ext cx="1609155" cy="6134271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5660396" y="3352553"/>
            <a:ext cx="11160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YRP1/TRP1</a:t>
            </a:r>
          </a:p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7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497941" y="314729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864207" y="317415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415802" y="355956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415802" y="3942295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05727" y="626368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415802" y="317682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415802" y="432502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30324" y="30189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30323" y="345382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30322" y="388000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30322" y="496084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30322" y="439616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405727" y="571394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64325" y="5568755"/>
            <a:ext cx="2116255" cy="65942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Rechteck 24"/>
          <p:cNvSpPr/>
          <p:nvPr/>
        </p:nvSpPr>
        <p:spPr>
          <a:xfrm>
            <a:off x="4094193" y="3176827"/>
            <a:ext cx="1450109" cy="65942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Textfeld 25"/>
          <p:cNvSpPr txBox="1"/>
          <p:nvPr/>
        </p:nvSpPr>
        <p:spPr>
          <a:xfrm>
            <a:off x="405727" y="7067213"/>
            <a:ext cx="55619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Wester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- 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a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~25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YRP1/TRP1 (~75kDa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M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MSC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B. </a:t>
            </a:r>
            <a:endParaRPr lang="de-DE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5045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81886" y="4411653"/>
            <a:ext cx="13051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0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3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1843169" y="369791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231864" y="369790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4" t="15670" r="70483" b="17179"/>
          <a:stretch/>
        </p:blipFill>
        <p:spPr>
          <a:xfrm>
            <a:off x="1297540" y="806562"/>
            <a:ext cx="1744910" cy="4420998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082" t="15416" r="24101" b="18453"/>
          <a:stretch/>
        </p:blipFill>
        <p:spPr>
          <a:xfrm>
            <a:off x="3720841" y="806562"/>
            <a:ext cx="1963024" cy="4353886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5596630" y="3764327"/>
            <a:ext cx="12025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B/</a:t>
            </a:r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44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360408" y="369791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749103" y="369790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042450" y="310526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042964" y="348732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041936" y="389987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387051" y="3899879"/>
            <a:ext cx="1615797" cy="985541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Rechteck 16"/>
          <p:cNvSpPr/>
          <p:nvPr/>
        </p:nvSpPr>
        <p:spPr>
          <a:xfrm>
            <a:off x="4068068" y="3733221"/>
            <a:ext cx="1615797" cy="492771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Textfeld 17"/>
          <p:cNvSpPr txBox="1"/>
          <p:nvPr/>
        </p:nvSpPr>
        <p:spPr>
          <a:xfrm>
            <a:off x="600170" y="5396843"/>
            <a:ext cx="55619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Wester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- 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90 (~30-4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CTB/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~44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M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MSC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B. </a:t>
            </a:r>
            <a:endParaRPr lang="de-DE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867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6</Words>
  <Application>Microsoft Office PowerPoint</Application>
  <PresentationFormat>A4-Papier (210 x 297 mm)</PresentationFormat>
  <Paragraphs>39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22</cp:revision>
  <dcterms:created xsi:type="dcterms:W3CDTF">2024-02-19T08:50:53Z</dcterms:created>
  <dcterms:modified xsi:type="dcterms:W3CDTF">2024-02-21T11:17:10Z</dcterms:modified>
</cp:coreProperties>
</file>